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3" r:id="rId4"/>
    <p:sldId id="260" r:id="rId5"/>
    <p:sldId id="259" r:id="rId6"/>
    <p:sldId id="261" r:id="rId7"/>
    <p:sldId id="278" r:id="rId8"/>
    <p:sldId id="279" r:id="rId9"/>
    <p:sldId id="262" r:id="rId10"/>
    <p:sldId id="280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CBF33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A7138-C731-4922-B440-A95220ED51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63C550-4FE8-49E7-9995-14F1C398C2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3DE313-B217-4D4D-839C-38272A1ED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E31817-229C-4511-AC69-4E3DE879E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158F5-01A1-43C9-8603-9D50FA15E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5537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6F7A0-2150-415F-986E-3B761F0438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431E29-4EE8-4C6F-AFD3-E3F19BC61B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8BF625-82D9-488B-8464-1D645EDA0C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BA3F78-9770-42EB-AA00-487EFE55F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B01419-5E96-47D6-9D39-93EAB6F06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36739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1673D5-9E45-47E8-9C1F-70414E9D15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01D3AD-C339-430F-A84A-7BA850133E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279E02-456B-4B47-BC03-0A5BE430E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65211B-EAC5-46EB-A4ED-6E42E1FC2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1ECD57-EBF5-4BC5-B4B9-143F60253B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94155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43442-4CF2-4485-916E-095F12353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B84C5F-FC8E-4581-8851-61D5FDAF63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6A301-EC7F-435A-B308-5D9D29C2C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09F3B7-F46E-40FD-9FB2-EF7092007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06813-F914-4853-B0B2-13C6A60D0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15843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F7F7C-AC38-408F-BB0F-4241A38AD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4FB0BC-8812-4BE1-821D-F8C655128C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51ED6-48B4-4C9C-8FDA-09116C52D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AED492-432A-46AD-B7B7-BB593B1A1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44137A-DC5F-4ABD-9E7C-BD33EEBAA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5787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917A7-DD39-44AC-9858-52BCD6D99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A83C52-E7D2-45BC-B18A-78A95A27C8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126410-F395-44B7-98C8-AE79AFB111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E1866F-E1F6-4C51-B4B2-FAEEF557D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6CF0A4-5BB7-472E-9C28-59DED0808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8302F8-E6DE-4584-8276-AC2FF4495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8029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BEAA35-E6FD-4530-A750-ACD970898D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685B8D-CA46-44FC-B23C-E2E925C226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83CE1B-0D3F-49F1-9254-FFE45CAD81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67F1F8C-E47C-4AD4-9F25-13C6CE3F5C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863463-DA5F-4882-9031-E0EFAA9186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9A12F9-AC96-45A9-A736-674B509BC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3FB885-9059-4DA1-9A1C-0F4E98DBC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576EB0-DA7D-40BD-A039-8E8559A64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5297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68BE8-375D-4370-B1DD-579EB9404E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B8C887-5341-4AF4-B06B-A52312843E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3C94A8-39E3-4212-A432-0F45B3F93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C639B08-F172-42CD-9434-640E5411F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16812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0FD6D3-2D24-4751-A4EB-87B871B11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2E2408-E12A-429B-BB02-570C93E93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BD2A75-BDBC-4B29-8294-A4E994ACB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111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B420C-7587-40AE-AD95-E978B9AC39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35D3CC-3836-4B68-A744-AB00329C1C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88BB8A-ED60-448C-AC90-2F3BB08080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4EEAB0-6E88-4EFC-A2D1-6705279AB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35FE23-1E62-420F-A8D7-A19BFB733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A1DF67-8484-42B0-A70E-4953BA62A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13139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2DE750-6E92-447D-A2E5-05BA9617B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B97E1C-83FC-4414-86FC-768F5E8BEA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BA1E09-D7B7-4503-A6FE-73DA7F8A1A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0893F3-3842-4C8C-8F40-A21E45420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90DAEC-53CD-4994-B98F-3068FA74A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E3F262-178E-480D-A671-9C6D48B41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4565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5F6412-43D8-4FB2-A1B5-7119D3401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84DD2A-8568-4AF3-BABB-25BC49A31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EC04E-044D-43F9-A4BD-94EB5B3EA7C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5165A-3330-4CB2-8D89-03D2F3CBE0DB}" type="datetimeFigureOut">
              <a:rPr lang="en-CA" smtClean="0"/>
              <a:t>2022-10-26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A86644-43A7-4A31-854A-F34E8817E8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D2CB37-236B-4D88-A455-38C1F5262F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15EB-3FF7-44C1-909B-D7F343542D0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34296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G"/><Relationship Id="rId2" Type="http://schemas.openxmlformats.org/officeDocument/2006/relationships/image" Target="../media/image4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6.jpeg"/><Relationship Id="rId4" Type="http://schemas.openxmlformats.org/officeDocument/2006/relationships/image" Target="../media/image45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18" Type="http://schemas.openxmlformats.org/officeDocument/2006/relationships/image" Target="../media/image18.jpeg"/><Relationship Id="rId26" Type="http://schemas.openxmlformats.org/officeDocument/2006/relationships/image" Target="../media/image26.jpeg"/><Relationship Id="rId3" Type="http://schemas.openxmlformats.org/officeDocument/2006/relationships/image" Target="../media/image3.jpeg"/><Relationship Id="rId21" Type="http://schemas.openxmlformats.org/officeDocument/2006/relationships/image" Target="../media/image21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17" Type="http://schemas.openxmlformats.org/officeDocument/2006/relationships/image" Target="../media/image17.jpeg"/><Relationship Id="rId25" Type="http://schemas.openxmlformats.org/officeDocument/2006/relationships/image" Target="../media/image25.jpeg"/><Relationship Id="rId2" Type="http://schemas.openxmlformats.org/officeDocument/2006/relationships/image" Target="../media/image2.jpeg"/><Relationship Id="rId16" Type="http://schemas.openxmlformats.org/officeDocument/2006/relationships/image" Target="../media/image16.jpeg"/><Relationship Id="rId20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24" Type="http://schemas.openxmlformats.org/officeDocument/2006/relationships/image" Target="../media/image24.jpeg"/><Relationship Id="rId5" Type="http://schemas.openxmlformats.org/officeDocument/2006/relationships/image" Target="../media/image5.jpeg"/><Relationship Id="rId15" Type="http://schemas.openxmlformats.org/officeDocument/2006/relationships/image" Target="../media/image15.jpeg"/><Relationship Id="rId23" Type="http://schemas.openxmlformats.org/officeDocument/2006/relationships/image" Target="../media/image23.jpeg"/><Relationship Id="rId28" Type="http://schemas.openxmlformats.org/officeDocument/2006/relationships/image" Target="../media/image28.png"/><Relationship Id="rId10" Type="http://schemas.openxmlformats.org/officeDocument/2006/relationships/image" Target="../media/image10.jpeg"/><Relationship Id="rId19" Type="http://schemas.openxmlformats.org/officeDocument/2006/relationships/image" Target="../media/image19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Relationship Id="rId22" Type="http://schemas.openxmlformats.org/officeDocument/2006/relationships/image" Target="../media/image22.jpeg"/><Relationship Id="rId27" Type="http://schemas.openxmlformats.org/officeDocument/2006/relationships/image" Target="../media/image27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"/><Relationship Id="rId2" Type="http://schemas.openxmlformats.org/officeDocument/2006/relationships/image" Target="../media/image4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2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0E2C8C9-AA03-43AB-B1F5-615A86022C09}"/>
              </a:ext>
            </a:extLst>
          </p:cNvPr>
          <p:cNvSpPr txBox="1"/>
          <p:nvPr/>
        </p:nvSpPr>
        <p:spPr>
          <a:xfrm>
            <a:off x="2893931" y="6396543"/>
            <a:ext cx="748498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NA-Seq sample collection and data analysis workflow</a:t>
            </a:r>
            <a:endParaRPr lang="en-C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C3CBA11B-B485-4E7B-E3D1-E377ECD853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0732" y="-4257"/>
            <a:ext cx="91440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63271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itting, indoor, mollusk, invertebrate&#10;&#10;Description automatically generated">
            <a:extLst>
              <a:ext uri="{FF2B5EF4-FFF2-40B4-BE49-F238E27FC236}">
                <a16:creationId xmlns:a16="http://schemas.microsoft.com/office/drawing/2014/main" id="{8A0848E4-3C4F-42A3-BAE4-1360E9C397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55667" y="1552915"/>
            <a:ext cx="3552827" cy="2095501"/>
          </a:xfrm>
          <a:prstGeom prst="rect">
            <a:avLst/>
          </a:prstGeom>
        </p:spPr>
      </p:pic>
      <p:pic>
        <p:nvPicPr>
          <p:cNvPr id="5" name="Picture 4" descr="A picture containing food, fork, sandwich, snack food&#10;&#10;Description automatically generated">
            <a:extLst>
              <a:ext uri="{FF2B5EF4-FFF2-40B4-BE49-F238E27FC236}">
                <a16:creationId xmlns:a16="http://schemas.microsoft.com/office/drawing/2014/main" id="{80851E01-BF63-4C72-AF25-7729941472D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120110" y="1265579"/>
            <a:ext cx="3556000" cy="2667000"/>
          </a:xfrm>
          <a:prstGeom prst="rect">
            <a:avLst/>
          </a:prstGeom>
        </p:spPr>
      </p:pic>
      <p:pic>
        <p:nvPicPr>
          <p:cNvPr id="6" name="Picture 5" descr="A picture containing food, dish, meat, close&#10;&#10;Description automatically generated">
            <a:extLst>
              <a:ext uri="{FF2B5EF4-FFF2-40B4-BE49-F238E27FC236}">
                <a16:creationId xmlns:a16="http://schemas.microsoft.com/office/drawing/2014/main" id="{D153E5CB-2E38-42C2-93EF-FFAB137189F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58" t="35066" r="17686" b="16267"/>
          <a:stretch/>
        </p:blipFill>
        <p:spPr>
          <a:xfrm rot="5400000">
            <a:off x="8497411" y="1138965"/>
            <a:ext cx="3552828" cy="291705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E8A9606-7624-48A1-8AD8-1DE93866C8F8}"/>
              </a:ext>
            </a:extLst>
          </p:cNvPr>
          <p:cNvSpPr txBox="1"/>
          <p:nvPr/>
        </p:nvSpPr>
        <p:spPr>
          <a:xfrm>
            <a:off x="3868112" y="5526723"/>
            <a:ext cx="609920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eromonas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lmonicida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223 infected lumpfish</a:t>
            </a:r>
            <a:endParaRPr lang="en-CA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EDD056D-A238-39F7-CE1B-43CCF80040A4}"/>
              </a:ext>
            </a:extLst>
          </p:cNvPr>
          <p:cNvSpPr txBox="1"/>
          <p:nvPr/>
        </p:nvSpPr>
        <p:spPr>
          <a:xfrm>
            <a:off x="175083" y="734423"/>
            <a:ext cx="437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4F6FCEE-283E-9919-64E7-4570314FB635}"/>
              </a:ext>
            </a:extLst>
          </p:cNvPr>
          <p:cNvSpPr txBox="1"/>
          <p:nvPr/>
        </p:nvSpPr>
        <p:spPr>
          <a:xfrm>
            <a:off x="3062564" y="734423"/>
            <a:ext cx="437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F6526B-9E27-A7AE-1255-F7175C4299EF}"/>
              </a:ext>
            </a:extLst>
          </p:cNvPr>
          <p:cNvSpPr txBox="1"/>
          <p:nvPr/>
        </p:nvSpPr>
        <p:spPr>
          <a:xfrm>
            <a:off x="6384572" y="729544"/>
            <a:ext cx="4371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pic>
        <p:nvPicPr>
          <p:cNvPr id="10" name="Picture 9" descr="A picture containing indoor, fish, soft-finned fish, eaten&#10;&#10;Description automatically generated">
            <a:extLst>
              <a:ext uri="{FF2B5EF4-FFF2-40B4-BE49-F238E27FC236}">
                <a16:creationId xmlns:a16="http://schemas.microsoft.com/office/drawing/2014/main" id="{6AF0E32D-8B05-8D0D-E632-FC36D8D1B9D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7" t="10043" r="1429" b="23891"/>
          <a:stretch/>
        </p:blipFill>
        <p:spPr>
          <a:xfrm rot="5400000">
            <a:off x="6048438" y="1680628"/>
            <a:ext cx="3604557" cy="1866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3602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F2B9880-5094-4549-ADC7-21B408824448}"/>
              </a:ext>
            </a:extLst>
          </p:cNvPr>
          <p:cNvSpPr txBox="1"/>
          <p:nvPr/>
        </p:nvSpPr>
        <p:spPr>
          <a:xfrm>
            <a:off x="2542381" y="6041600"/>
            <a:ext cx="7782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  Quality of the RNA samples and sequenced reads</a:t>
            </a:r>
            <a:endParaRPr lang="en-C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DB150A9-FD04-25E5-A044-F938C623598D}"/>
              </a:ext>
            </a:extLst>
          </p:cNvPr>
          <p:cNvGrpSpPr/>
          <p:nvPr/>
        </p:nvGrpSpPr>
        <p:grpSpPr>
          <a:xfrm>
            <a:off x="949491" y="609209"/>
            <a:ext cx="10081117" cy="5059128"/>
            <a:chOff x="666462" y="279780"/>
            <a:chExt cx="10081117" cy="505912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736B19A-B02F-465B-9BCA-62F21A80C273}"/>
                </a:ext>
              </a:extLst>
            </p:cNvPr>
            <p:cNvSpPr txBox="1"/>
            <p:nvPr/>
          </p:nvSpPr>
          <p:spPr>
            <a:xfrm>
              <a:off x="666462" y="279780"/>
              <a:ext cx="439007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.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EAAD6615-0E57-4652-9035-B83B24FC0493}"/>
                </a:ext>
              </a:extLst>
            </p:cNvPr>
            <p:cNvGrpSpPr/>
            <p:nvPr/>
          </p:nvGrpSpPr>
          <p:grpSpPr>
            <a:xfrm>
              <a:off x="2041287" y="750580"/>
              <a:ext cx="3197072" cy="1772834"/>
              <a:chOff x="7309464" y="363960"/>
              <a:chExt cx="3647061" cy="2253899"/>
            </a:xfrm>
          </p:grpSpPr>
          <p:pic>
            <p:nvPicPr>
              <p:cNvPr id="7" name="Picture 6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BDEF91B5-B395-49AF-BDB3-3D08F81B3B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09465" y="363960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8" name="Picture 7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211BDB5E-3B00-42FA-9434-5942F8FD631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1999" y="363960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9" name="Picture 8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7289AA1C-7967-4883-9F56-337B2BA592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4533" y="363960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0" name="Picture 9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CD52A971-3950-4291-BF09-FB2A0C4D3E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25642" y="1135731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1" name="Picture 10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5043E7D4-C3C3-40D6-9032-FE4FB0E5F6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1998" y="1125975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2" name="Picture 11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350955BD-D0EA-4B18-91A9-6B82AD656A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58354" y="1092779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3" name="Picture 12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207994F1-8747-4D88-92B6-27906A21F3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09464" y="1894154"/>
                <a:ext cx="1181810" cy="723705"/>
              </a:xfrm>
              <a:prstGeom prst="rect">
                <a:avLst/>
              </a:prstGeom>
            </p:spPr>
          </p:pic>
          <p:pic>
            <p:nvPicPr>
              <p:cNvPr id="14" name="Picture 13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674D62F6-B1F4-405F-B3A0-0DAA1E4CB1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3001" y="1882545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5" name="Picture 14" descr="A screenshot of a social media post&#10;&#10;Description automatically generated">
                <a:extLst>
                  <a:ext uri="{FF2B5EF4-FFF2-40B4-BE49-F238E27FC236}">
                    <a16:creationId xmlns:a16="http://schemas.microsoft.com/office/drawing/2014/main" id="{D5223799-C786-44E1-A6B5-F48D5F7A45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74715" y="1859437"/>
                <a:ext cx="1181810" cy="723706"/>
              </a:xfrm>
              <a:prstGeom prst="rect">
                <a:avLst/>
              </a:prstGeom>
            </p:spPr>
          </p:pic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B66EE37-5974-4243-9FE7-AC6F11C09231}"/>
                </a:ext>
              </a:extLst>
            </p:cNvPr>
            <p:cNvGrpSpPr/>
            <p:nvPr/>
          </p:nvGrpSpPr>
          <p:grpSpPr>
            <a:xfrm>
              <a:off x="2028615" y="3295758"/>
              <a:ext cx="3196912" cy="1763702"/>
              <a:chOff x="7360189" y="2836493"/>
              <a:chExt cx="3579974" cy="2242290"/>
            </a:xfrm>
          </p:grpSpPr>
          <p:pic>
            <p:nvPicPr>
              <p:cNvPr id="17" name="Picture 16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5FFA1A29-03EC-4B5C-B6E2-07803D377F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0189" y="2854892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18" name="Picture 17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707C02E7-3C6A-4480-81F9-DB86A7A77D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23974" y="2836493"/>
                <a:ext cx="1181808" cy="723705"/>
              </a:xfrm>
              <a:prstGeom prst="rect">
                <a:avLst/>
              </a:prstGeom>
            </p:spPr>
          </p:pic>
          <p:pic>
            <p:nvPicPr>
              <p:cNvPr id="19" name="Picture 18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E2A668CC-1545-48FF-B77D-0385F7473A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18882" y="2862856"/>
                <a:ext cx="1181808" cy="723705"/>
              </a:xfrm>
              <a:prstGeom prst="rect">
                <a:avLst/>
              </a:prstGeom>
            </p:spPr>
          </p:pic>
          <p:pic>
            <p:nvPicPr>
              <p:cNvPr id="20" name="Picture 19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1BE33A20-9185-4FC9-B0BB-B95BCB6540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0189" y="3624416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21" name="Picture 20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26D5C1BC-2EE9-4429-84D1-76DD2F9AE5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34052" y="3601137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66F4DCF5-9F89-4BB1-ADD0-D946C0BC11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41997" y="3598052"/>
                <a:ext cx="1181808" cy="723705"/>
              </a:xfrm>
              <a:prstGeom prst="rect">
                <a:avLst/>
              </a:prstGeom>
            </p:spPr>
          </p:pic>
          <p:pic>
            <p:nvPicPr>
              <p:cNvPr id="23" name="Picture 22" descr="A picture containing mirror&#10;&#10;Description automatically generated">
                <a:extLst>
                  <a:ext uri="{FF2B5EF4-FFF2-40B4-BE49-F238E27FC236}">
                    <a16:creationId xmlns:a16="http://schemas.microsoft.com/office/drawing/2014/main" id="{B9D32BC6-B77C-4B5B-92DA-5F77876F0D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0189" y="4333741"/>
                <a:ext cx="1181809" cy="723706"/>
              </a:xfrm>
              <a:prstGeom prst="rect">
                <a:avLst/>
              </a:prstGeom>
            </p:spPr>
          </p:pic>
          <p:pic>
            <p:nvPicPr>
              <p:cNvPr id="24" name="Picture 23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06D02B26-87A5-4922-82D1-5539060ED2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552243" y="4355078"/>
                <a:ext cx="1181808" cy="723705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FE5E8408-D23B-4810-96EA-FB0B554F24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58354" y="4354586"/>
                <a:ext cx="1181809" cy="723706"/>
              </a:xfrm>
              <a:prstGeom prst="rect">
                <a:avLst/>
              </a:prstGeom>
            </p:spPr>
          </p:pic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C39BB64D-0F16-404A-8ABB-21DCE57D0CD9}"/>
                </a:ext>
              </a:extLst>
            </p:cNvPr>
            <p:cNvGrpSpPr/>
            <p:nvPr/>
          </p:nvGrpSpPr>
          <p:grpSpPr>
            <a:xfrm>
              <a:off x="7496723" y="750580"/>
              <a:ext cx="3161316" cy="1744945"/>
              <a:chOff x="3908952" y="3862935"/>
              <a:chExt cx="3351933" cy="2096554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BA3569B6-41FA-47EA-B31E-D421F38A2D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15400" y="3862935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28" name="Picture 27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2160B889-6D36-473C-9826-14653B1E94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28935" y="3889194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29" name="Picture 28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1FD451B2-BD77-442E-8892-ED29ABC8A2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32592" y="3889194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0" name="Picture 29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1BEC58AA-3B6D-425C-8669-8AEC8962AA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08952" y="4549880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1" name="Picture 30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AA2B947A-AE01-483B-BAD6-C0A0C6D574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0026" y="4564477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2" name="Picture 31" descr="A close up of a piece of paper&#10;&#10;Description automatically generated">
                <a:extLst>
                  <a:ext uri="{FF2B5EF4-FFF2-40B4-BE49-F238E27FC236}">
                    <a16:creationId xmlns:a16="http://schemas.microsoft.com/office/drawing/2014/main" id="{3B34AFEF-EF2B-4BD6-BA39-8D5225B256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36232" y="4574816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3" name="Picture 32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7AB62253-E09C-4B27-9F4E-9886A21325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28596" y="5259961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4" name="Picture 33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AC74EA3E-8647-4A8D-B1FE-4CCA95EAF2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50025" y="5252206"/>
                <a:ext cx="1100339" cy="673816"/>
              </a:xfrm>
              <a:prstGeom prst="rect">
                <a:avLst/>
              </a:prstGeom>
            </p:spPr>
          </p:pic>
          <p:pic>
            <p:nvPicPr>
              <p:cNvPr id="35" name="Picture 34" descr="A screenshot of a cell phone&#10;&#10;Description automatically generated">
                <a:extLst>
                  <a:ext uri="{FF2B5EF4-FFF2-40B4-BE49-F238E27FC236}">
                    <a16:creationId xmlns:a16="http://schemas.microsoft.com/office/drawing/2014/main" id="{4DF1CB81-A452-45AE-B810-FC5F152842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60546" y="5285673"/>
                <a:ext cx="1100339" cy="673816"/>
              </a:xfrm>
              <a:prstGeom prst="rect">
                <a:avLst/>
              </a:prstGeom>
            </p:spPr>
          </p:pic>
        </p:grp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FB51992F-36B7-461F-9E5D-736622F96860}"/>
                </a:ext>
              </a:extLst>
            </p:cNvPr>
            <p:cNvSpPr txBox="1"/>
            <p:nvPr/>
          </p:nvSpPr>
          <p:spPr>
            <a:xfrm>
              <a:off x="3091462" y="377001"/>
              <a:ext cx="11335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ead kidney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6327ED5-94F9-4887-80E0-9FDE991B9EA4}"/>
                </a:ext>
              </a:extLst>
            </p:cNvPr>
            <p:cNvSpPr txBox="1"/>
            <p:nvPr/>
          </p:nvSpPr>
          <p:spPr>
            <a:xfrm>
              <a:off x="3085934" y="2904741"/>
              <a:ext cx="11335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leen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057E16A-0130-4802-8202-F5E15B75CCE1}"/>
                </a:ext>
              </a:extLst>
            </p:cNvPr>
            <p:cNvSpPr txBox="1"/>
            <p:nvPr/>
          </p:nvSpPr>
          <p:spPr>
            <a:xfrm>
              <a:off x="8457181" y="377001"/>
              <a:ext cx="11335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ver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4045F31-1F97-4235-B2BE-957F0C8B4E73}"/>
                </a:ext>
              </a:extLst>
            </p:cNvPr>
            <p:cNvSpPr txBox="1"/>
            <p:nvPr/>
          </p:nvSpPr>
          <p:spPr>
            <a:xfrm>
              <a:off x="682724" y="2934813"/>
              <a:ext cx="439007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B.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5047F74-EAE9-4547-999C-F09261B90C86}"/>
                </a:ext>
              </a:extLst>
            </p:cNvPr>
            <p:cNvSpPr txBox="1"/>
            <p:nvPr/>
          </p:nvSpPr>
          <p:spPr>
            <a:xfrm>
              <a:off x="5931263" y="279780"/>
              <a:ext cx="439007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.</a:t>
              </a:r>
            </a:p>
          </p:txBody>
        </p:sp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9F8C0917-C8CD-4525-8E7E-14CFBBA430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/>
            <a:stretch>
              <a:fillRect/>
            </a:stretch>
          </p:blipFill>
          <p:spPr>
            <a:xfrm>
              <a:off x="7156885" y="2945113"/>
              <a:ext cx="3590694" cy="2393795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BE5A542A-A958-41CC-834D-317A0F9D51E7}"/>
                </a:ext>
              </a:extLst>
            </p:cNvPr>
            <p:cNvSpPr txBox="1"/>
            <p:nvPr/>
          </p:nvSpPr>
          <p:spPr>
            <a:xfrm>
              <a:off x="921870" y="838938"/>
              <a:ext cx="1133599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 Control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8481001-598B-4F73-929F-2F5636B6B8FD}"/>
                </a:ext>
              </a:extLst>
            </p:cNvPr>
            <p:cNvSpPr txBox="1"/>
            <p:nvPr/>
          </p:nvSpPr>
          <p:spPr>
            <a:xfrm>
              <a:off x="921869" y="3337137"/>
              <a:ext cx="1133599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 Control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80D86D2-4C5E-422D-B5C8-84433B24D454}"/>
                </a:ext>
              </a:extLst>
            </p:cNvPr>
            <p:cNvSpPr txBox="1"/>
            <p:nvPr/>
          </p:nvSpPr>
          <p:spPr>
            <a:xfrm>
              <a:off x="6363124" y="838938"/>
              <a:ext cx="1133599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am Control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C351617-7CA9-40D8-90BB-33D75FED2926}"/>
                </a:ext>
              </a:extLst>
            </p:cNvPr>
            <p:cNvSpPr txBox="1"/>
            <p:nvPr/>
          </p:nvSpPr>
          <p:spPr>
            <a:xfrm>
              <a:off x="5932622" y="2967068"/>
              <a:ext cx="439007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.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7851FC9-8C15-4D95-BD3F-94A991810287}"/>
                </a:ext>
              </a:extLst>
            </p:cNvPr>
            <p:cNvSpPr txBox="1"/>
            <p:nvPr/>
          </p:nvSpPr>
          <p:spPr>
            <a:xfrm>
              <a:off x="1526826" y="1449889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dpi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7CD1679-D2C2-4836-8DF1-6AC2C020EDB3}"/>
                </a:ext>
              </a:extLst>
            </p:cNvPr>
            <p:cNvSpPr txBox="1"/>
            <p:nvPr/>
          </p:nvSpPr>
          <p:spPr>
            <a:xfrm>
              <a:off x="6919019" y="1399977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dpi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2EC9141-4031-4DC2-B03E-5A4275F93F45}"/>
                </a:ext>
              </a:extLst>
            </p:cNvPr>
            <p:cNvSpPr txBox="1"/>
            <p:nvPr/>
          </p:nvSpPr>
          <p:spPr>
            <a:xfrm>
              <a:off x="1463584" y="3925833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dpi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2928703-A7E3-448B-81FB-2727D96D2FBB}"/>
                </a:ext>
              </a:extLst>
            </p:cNvPr>
            <p:cNvSpPr txBox="1"/>
            <p:nvPr/>
          </p:nvSpPr>
          <p:spPr>
            <a:xfrm>
              <a:off x="1450912" y="2050807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dpi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112B3A40-8EBE-42B2-861C-3FF9C133A8A7}"/>
                </a:ext>
              </a:extLst>
            </p:cNvPr>
            <p:cNvSpPr txBox="1"/>
            <p:nvPr/>
          </p:nvSpPr>
          <p:spPr>
            <a:xfrm>
              <a:off x="6881493" y="2032352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dpi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45EB28E-48C6-4FA7-AE9B-9EE81E3D869A}"/>
                </a:ext>
              </a:extLst>
            </p:cNvPr>
            <p:cNvSpPr txBox="1"/>
            <p:nvPr/>
          </p:nvSpPr>
          <p:spPr>
            <a:xfrm>
              <a:off x="1403833" y="4442183"/>
              <a:ext cx="577703" cy="2858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dp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68876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26F19C6E-555C-4748-B79D-7E05EBA2D03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817" y="199504"/>
            <a:ext cx="6889721" cy="618466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8EBDB98-21A1-46BB-B55B-8C4906C94D40}"/>
              </a:ext>
            </a:extLst>
          </p:cNvPr>
          <p:cNvSpPr txBox="1"/>
          <p:nvPr/>
        </p:nvSpPr>
        <p:spPr>
          <a:xfrm>
            <a:off x="8103190" y="2967335"/>
            <a:ext cx="369916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lobal gene expression profile of different lumpfish organs infected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lmonici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4291184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6A29526B-4D1B-4110-8430-D39FF76C639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114"/>
          <a:stretch/>
        </p:blipFill>
        <p:spPr>
          <a:xfrm>
            <a:off x="2528862" y="575763"/>
            <a:ext cx="6547043" cy="472842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32B102A-A512-4C74-8BF7-5F8932887DE1}"/>
              </a:ext>
            </a:extLst>
          </p:cNvPr>
          <p:cNvSpPr txBox="1"/>
          <p:nvPr/>
        </p:nvSpPr>
        <p:spPr>
          <a:xfrm>
            <a:off x="3226126" y="5403457"/>
            <a:ext cx="6172397" cy="6152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CA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CA" sz="2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CA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4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uality of transcriptome assembly</a:t>
            </a:r>
            <a:endParaRPr lang="en-CA" sz="2000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6386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>
            <a:extLst>
              <a:ext uri="{FF2B5EF4-FFF2-40B4-BE49-F238E27FC236}">
                <a16:creationId xmlns:a16="http://schemas.microsoft.com/office/drawing/2014/main" id="{929ED705-5731-46B6-BBAF-F6B1F35610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2916" y="22096"/>
            <a:ext cx="3507239" cy="3507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">
            <a:extLst>
              <a:ext uri="{FF2B5EF4-FFF2-40B4-BE49-F238E27FC236}">
                <a16:creationId xmlns:a16="http://schemas.microsoft.com/office/drawing/2014/main" id="{399FE93D-F9E7-402A-BFCD-D6ED58BB5E2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1402" y="0"/>
            <a:ext cx="3507239" cy="3507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>
            <a:extLst>
              <a:ext uri="{FF2B5EF4-FFF2-40B4-BE49-F238E27FC236}">
                <a16:creationId xmlns:a16="http://schemas.microsoft.com/office/drawing/2014/main" id="{97DE8105-9D0A-4A11-997E-75F3F97EB0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8726" y="3244174"/>
            <a:ext cx="3507239" cy="3507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1700E26-B831-4F9D-9277-DAB1844CEDF3}"/>
              </a:ext>
            </a:extLst>
          </p:cNvPr>
          <p:cNvSpPr txBox="1"/>
          <p:nvPr/>
        </p:nvSpPr>
        <p:spPr>
          <a:xfrm>
            <a:off x="8677105" y="3714950"/>
            <a:ext cx="23929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anscript expression profile comparison</a:t>
            </a:r>
            <a:endParaRPr lang="en-CA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2">
            <a:extLst>
              <a:ext uri="{FF2B5EF4-FFF2-40B4-BE49-F238E27FC236}">
                <a16:creationId xmlns:a16="http://schemas.microsoft.com/office/drawing/2014/main" id="{909257AA-7DE1-47AE-8E81-A201C753045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06" t="4097" r="8316" b="3704"/>
          <a:stretch/>
        </p:blipFill>
        <p:spPr bwMode="auto">
          <a:xfrm>
            <a:off x="5003510" y="3244174"/>
            <a:ext cx="3126049" cy="3507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A4D73FA-D250-4321-80DB-F82815396966}"/>
              </a:ext>
            </a:extLst>
          </p:cNvPr>
          <p:cNvSpPr txBox="1"/>
          <p:nvPr/>
        </p:nvSpPr>
        <p:spPr>
          <a:xfrm>
            <a:off x="129123" y="178593"/>
            <a:ext cx="735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41FBA38-410E-4847-98B2-BBCDD0241605}"/>
              </a:ext>
            </a:extLst>
          </p:cNvPr>
          <p:cNvSpPr txBox="1"/>
          <p:nvPr/>
        </p:nvSpPr>
        <p:spPr>
          <a:xfrm>
            <a:off x="4750240" y="3244174"/>
            <a:ext cx="735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9B85781-36B0-4AAC-AD2D-DB286DF82469}"/>
              </a:ext>
            </a:extLst>
          </p:cNvPr>
          <p:cNvSpPr txBox="1"/>
          <p:nvPr/>
        </p:nvSpPr>
        <p:spPr>
          <a:xfrm>
            <a:off x="146627" y="3244334"/>
            <a:ext cx="735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DDE4302-2857-41C6-9EF8-D05899EDF5B2}"/>
              </a:ext>
            </a:extLst>
          </p:cNvPr>
          <p:cNvSpPr txBox="1"/>
          <p:nvPr/>
        </p:nvSpPr>
        <p:spPr>
          <a:xfrm>
            <a:off x="4445092" y="178593"/>
            <a:ext cx="735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9861792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44FFBDC-2F82-47D2-BA87-3573F8D5D579}"/>
              </a:ext>
            </a:extLst>
          </p:cNvPr>
          <p:cNvSpPr txBox="1"/>
          <p:nvPr/>
        </p:nvSpPr>
        <p:spPr>
          <a:xfrm>
            <a:off x="202249" y="402669"/>
            <a:ext cx="404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201F10-CDC6-4283-96D3-011D630335A9}"/>
              </a:ext>
            </a:extLst>
          </p:cNvPr>
          <p:cNvSpPr txBox="1"/>
          <p:nvPr/>
        </p:nvSpPr>
        <p:spPr>
          <a:xfrm>
            <a:off x="5333168" y="294979"/>
            <a:ext cx="390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pic>
        <p:nvPicPr>
          <p:cNvPr id="9" name="Picture 8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BB96AAD2-AE29-4E6A-A8AD-B8E40AEF53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7370" t="8578" r="-303" b="72303"/>
          <a:stretch/>
        </p:blipFill>
        <p:spPr>
          <a:xfrm>
            <a:off x="10257114" y="766845"/>
            <a:ext cx="701749" cy="885846"/>
          </a:xfrm>
          <a:prstGeom prst="rect">
            <a:avLst/>
          </a:prstGeom>
        </p:spPr>
      </p:pic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id="{4EDA0810-62DE-4E85-8BAC-B65BE883F0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12469" y="420334"/>
            <a:ext cx="4095568" cy="487166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4258C1B-15B9-4332-BB1D-F85D5303BA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6169" y="939109"/>
            <a:ext cx="4314119" cy="4256341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AF2E5FC-2861-4FE2-A549-EDF7A0EFC5CD}"/>
              </a:ext>
            </a:extLst>
          </p:cNvPr>
          <p:cNvSpPr txBox="1"/>
          <p:nvPr/>
        </p:nvSpPr>
        <p:spPr>
          <a:xfrm>
            <a:off x="2908325" y="5918891"/>
            <a:ext cx="664594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CA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6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rrelation analysis, and hierarchical clustering</a:t>
            </a:r>
            <a:endParaRPr lang="en-CA" b="1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05829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diagram, bubble chart&#10;&#10;Description automatically generated">
            <a:extLst>
              <a:ext uri="{FF2B5EF4-FFF2-40B4-BE49-F238E27FC236}">
                <a16:creationId xmlns:a16="http://schemas.microsoft.com/office/drawing/2014/main" id="{32EB7C8D-9B6D-4036-BAD1-FB4259B1D1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9604" y="243192"/>
            <a:ext cx="7100118" cy="616733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DFD1865-EB8A-4A65-9946-3CB45646B5FC}"/>
              </a:ext>
            </a:extLst>
          </p:cNvPr>
          <p:cNvSpPr txBox="1"/>
          <p:nvPr/>
        </p:nvSpPr>
        <p:spPr>
          <a:xfrm>
            <a:off x="8510937" y="3076024"/>
            <a:ext cx="3209722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lueGO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based enriched gene ontology (GO) terms in lumpfish lymphoid organs at 3 dpi with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lmonicid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en-CA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48549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8E24D47-48B2-48FD-BFA0-11D82D942085}"/>
              </a:ext>
            </a:extLst>
          </p:cNvPr>
          <p:cNvSpPr txBox="1"/>
          <p:nvPr/>
        </p:nvSpPr>
        <p:spPr>
          <a:xfrm>
            <a:off x="9770978" y="2850766"/>
            <a:ext cx="24210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lueGO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based enriched gene ontology (GO) terms in lumpfish lymphoid organs at 10 dpi with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almonicida</a:t>
            </a:r>
            <a:endParaRPr lang="en-CA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9AB1C26B-F0C2-4802-BEAB-FFAB8D0464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8110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21652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computer&#10;&#10;Description automatically generated">
            <a:extLst>
              <a:ext uri="{FF2B5EF4-FFF2-40B4-BE49-F238E27FC236}">
                <a16:creationId xmlns:a16="http://schemas.microsoft.com/office/drawing/2014/main" id="{6C51DA56-BA69-4FAD-B468-D4B2E4F28D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8526" y="1114813"/>
            <a:ext cx="591863" cy="517678"/>
          </a:xfrm>
          <a:prstGeom prst="rect">
            <a:avLst/>
          </a:prstGeom>
        </p:spPr>
      </p:pic>
      <p:pic>
        <p:nvPicPr>
          <p:cNvPr id="8" name="Picture 7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84B56D23-9705-4ED8-8027-A3816C3E05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8085" y="460193"/>
            <a:ext cx="845999" cy="51767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EFC9CFC-22F3-415E-B51A-56205AD506E6}"/>
              </a:ext>
            </a:extLst>
          </p:cNvPr>
          <p:cNvSpPr txBox="1"/>
          <p:nvPr/>
        </p:nvSpPr>
        <p:spPr>
          <a:xfrm>
            <a:off x="8153020" y="3233033"/>
            <a:ext cx="37341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expression correlation between RT-qPCR and RNA-Seq data of 14 gene expressions</a:t>
            </a:r>
            <a:endParaRPr lang="en-CA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F389A24D-B12C-4A37-9504-B83771A555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2870426"/>
              </p:ext>
            </p:extLst>
          </p:nvPr>
        </p:nvGraphicFramePr>
        <p:xfrm>
          <a:off x="963302" y="56326"/>
          <a:ext cx="5229679" cy="67227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7221403" imgH="9292409" progId="Prism7.Document">
                  <p:embed/>
                </p:oleObj>
              </mc:Choice>
              <mc:Fallback>
                <p:oleObj name="Prism 7" r:id="rId4" imgW="7221403" imgH="9292409" progId="Prism7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29612CD-5FCF-48FF-BDD5-36B29B4F6E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63302" y="56326"/>
                        <a:ext cx="5229679" cy="67227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39703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71</TotalTime>
  <Words>171</Words>
  <Application>Microsoft Office PowerPoint</Application>
  <PresentationFormat>Widescreen</PresentationFormat>
  <Paragraphs>35</Paragraphs>
  <Slides>10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7" baseType="lpstr">
      <vt:lpstr>Arial</vt:lpstr>
      <vt:lpstr>Calibri</vt:lpstr>
      <vt:lpstr>Calibri Light</vt:lpstr>
      <vt:lpstr>Palatino Linotype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tu Chakraborty</dc:creator>
  <cp:lastModifiedBy>MDPI</cp:lastModifiedBy>
  <cp:revision>48</cp:revision>
  <dcterms:created xsi:type="dcterms:W3CDTF">2021-12-26T15:18:33Z</dcterms:created>
  <dcterms:modified xsi:type="dcterms:W3CDTF">2022-10-26T09:02:44Z</dcterms:modified>
</cp:coreProperties>
</file>